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11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默认节" id="{4C3C72ED-58BD-4395-92F2-919FA2D478EF}">
          <p14:sldIdLst>
            <p14:sldId id="311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980" autoAdjust="0"/>
    <p:restoredTop sz="96727" autoAdjust="0"/>
  </p:normalViewPr>
  <p:slideViewPr>
    <p:cSldViewPr snapToGrid="0">
      <p:cViewPr varScale="1">
        <p:scale>
          <a:sx n="86" d="100"/>
          <a:sy n="86" d="100"/>
        </p:scale>
        <p:origin x="287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7CD2233-616B-40A3-929C-AA85A602DE5C}" type="datetimeFigureOut">
              <a:rPr lang="zh-CN" altLang="en-US" smtClean="0"/>
              <a:t>2022/6/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3A64D55-A388-4C65-A67B-F375110519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82811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dirty="0"/>
              <a:t>Figure S3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3A64D55-A388-4C65-A67B-F37511051954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5866142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750EE-7704-498B-B930-E3105E69F080}" type="datetimeFigureOut">
              <a:rPr lang="zh-CN" altLang="en-US" smtClean="0"/>
              <a:t>2022/6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93BB1A-EB25-4D83-B350-6935D22B5C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39369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750EE-7704-498B-B930-E3105E69F080}" type="datetimeFigureOut">
              <a:rPr lang="zh-CN" altLang="en-US" smtClean="0"/>
              <a:t>2022/6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93BB1A-EB25-4D83-B350-6935D22B5C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45225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750EE-7704-498B-B930-E3105E69F080}" type="datetimeFigureOut">
              <a:rPr lang="zh-CN" altLang="en-US" smtClean="0"/>
              <a:t>2022/6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93BB1A-EB25-4D83-B350-6935D22B5C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668571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750EE-7704-498B-B930-E3105E69F080}" type="datetimeFigureOut">
              <a:rPr lang="zh-CN" altLang="en-US" smtClean="0"/>
              <a:t>2022/6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93BB1A-EB25-4D83-B350-6935D22B5C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182447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750EE-7704-498B-B930-E3105E69F080}" type="datetimeFigureOut">
              <a:rPr lang="zh-CN" altLang="en-US" smtClean="0"/>
              <a:t>2022/6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93BB1A-EB25-4D83-B350-6935D22B5C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98891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750EE-7704-498B-B930-E3105E69F080}" type="datetimeFigureOut">
              <a:rPr lang="zh-CN" altLang="en-US" smtClean="0"/>
              <a:t>2022/6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93BB1A-EB25-4D83-B350-6935D22B5C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68365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750EE-7704-498B-B930-E3105E69F080}" type="datetimeFigureOut">
              <a:rPr lang="zh-CN" altLang="en-US" smtClean="0"/>
              <a:t>2022/6/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93BB1A-EB25-4D83-B350-6935D22B5C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858764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750EE-7704-498B-B930-E3105E69F080}" type="datetimeFigureOut">
              <a:rPr lang="zh-CN" altLang="en-US" smtClean="0"/>
              <a:t>2022/6/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93BB1A-EB25-4D83-B350-6935D22B5C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29654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750EE-7704-498B-B930-E3105E69F080}" type="datetimeFigureOut">
              <a:rPr lang="zh-CN" altLang="en-US" smtClean="0"/>
              <a:t>2022/6/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93BB1A-EB25-4D83-B350-6935D22B5C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370872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750EE-7704-498B-B930-E3105E69F080}" type="datetimeFigureOut">
              <a:rPr lang="zh-CN" altLang="en-US" smtClean="0"/>
              <a:t>2022/6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93BB1A-EB25-4D83-B350-6935D22B5C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527811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750EE-7704-498B-B930-E3105E69F080}" type="datetimeFigureOut">
              <a:rPr lang="zh-CN" altLang="en-US" smtClean="0"/>
              <a:t>2022/6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93BB1A-EB25-4D83-B350-6935D22B5C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99784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B750EE-7704-498B-B930-E3105E69F080}" type="datetimeFigureOut">
              <a:rPr lang="zh-CN" altLang="en-US" smtClean="0"/>
              <a:t>2022/6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93BB1A-EB25-4D83-B350-6935D22B5C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124568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8.emf"/><Relationship Id="rId3" Type="http://schemas.openxmlformats.org/officeDocument/2006/relationships/oleObject" Target="../embeddings/oleObject1.bin"/><Relationship Id="rId21" Type="http://schemas.openxmlformats.org/officeDocument/2006/relationships/oleObject" Target="../embeddings/oleObject10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17" Type="http://schemas.openxmlformats.org/officeDocument/2006/relationships/oleObject" Target="../embeddings/oleObject8.bin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7.emf"/><Relationship Id="rId20" Type="http://schemas.openxmlformats.org/officeDocument/2006/relationships/image" Target="../media/image9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24" Type="http://schemas.openxmlformats.org/officeDocument/2006/relationships/image" Target="../media/image11.emf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23" Type="http://schemas.openxmlformats.org/officeDocument/2006/relationships/oleObject" Target="../embeddings/oleObject11.bin"/><Relationship Id="rId10" Type="http://schemas.openxmlformats.org/officeDocument/2006/relationships/image" Target="../media/image4.emf"/><Relationship Id="rId19" Type="http://schemas.openxmlformats.org/officeDocument/2006/relationships/oleObject" Target="../embeddings/oleObject9.bin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Relationship Id="rId22" Type="http://schemas.openxmlformats.org/officeDocument/2006/relationships/image" Target="../media/image10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对象 1">
            <a:extLst>
              <a:ext uri="{FF2B5EF4-FFF2-40B4-BE49-F238E27FC236}">
                <a16:creationId xmlns:a16="http://schemas.microsoft.com/office/drawing/2014/main" id="{80EA1420-99C0-4014-8C16-E0BC2551E843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859024" y="2038140"/>
          <a:ext cx="1657349" cy="130672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4139400" imgH="3265877" progId="Prism8.Document">
                  <p:embed/>
                </p:oleObj>
              </mc:Choice>
              <mc:Fallback>
                <p:oleObj name="Prism 8" r:id="rId3" imgW="4139400" imgH="3265877" progId="Prism8.Document">
                  <p:embed/>
                  <p:pic>
                    <p:nvPicPr>
                      <p:cNvPr id="2" name="对象 1">
                        <a:extLst>
                          <a:ext uri="{FF2B5EF4-FFF2-40B4-BE49-F238E27FC236}">
                            <a16:creationId xmlns:a16="http://schemas.microsoft.com/office/drawing/2014/main" id="{80EA1420-99C0-4014-8C16-E0BC2551E84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859024" y="2038140"/>
                        <a:ext cx="1657349" cy="130672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对象 14">
            <a:extLst>
              <a:ext uri="{FF2B5EF4-FFF2-40B4-BE49-F238E27FC236}">
                <a16:creationId xmlns:a16="http://schemas.microsoft.com/office/drawing/2014/main" id="{EF234B48-2E8F-4160-BA92-A363D525D5C3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416217" y="2029623"/>
          <a:ext cx="1657350" cy="13065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5" imgW="4139400" imgH="3265877" progId="Prism8.Document">
                  <p:embed/>
                </p:oleObj>
              </mc:Choice>
              <mc:Fallback>
                <p:oleObj name="Prism 8" r:id="rId5" imgW="4139400" imgH="3265877" progId="Prism8.Document">
                  <p:embed/>
                  <p:pic>
                    <p:nvPicPr>
                      <p:cNvPr id="15" name="对象 14">
                        <a:extLst>
                          <a:ext uri="{FF2B5EF4-FFF2-40B4-BE49-F238E27FC236}">
                            <a16:creationId xmlns:a16="http://schemas.microsoft.com/office/drawing/2014/main" id="{EF234B48-2E8F-4160-BA92-A363D525D5C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416217" y="2029623"/>
                        <a:ext cx="1657350" cy="13065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对象 15">
            <a:extLst>
              <a:ext uri="{FF2B5EF4-FFF2-40B4-BE49-F238E27FC236}">
                <a16:creationId xmlns:a16="http://schemas.microsoft.com/office/drawing/2014/main" id="{29CDBC65-960E-4A7E-BCFB-E804EBA47E88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40334" y="3674232"/>
          <a:ext cx="1630362" cy="1282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7" imgW="4139400" imgH="3256513" progId="Prism8.Document">
                  <p:embed/>
                </p:oleObj>
              </mc:Choice>
              <mc:Fallback>
                <p:oleObj name="Prism 8" r:id="rId7" imgW="4139400" imgH="3256513" progId="Prism8.Document">
                  <p:embed/>
                  <p:pic>
                    <p:nvPicPr>
                      <p:cNvPr id="16" name="对象 15">
                        <a:extLst>
                          <a:ext uri="{FF2B5EF4-FFF2-40B4-BE49-F238E27FC236}">
                            <a16:creationId xmlns:a16="http://schemas.microsoft.com/office/drawing/2014/main" id="{29CDBC65-960E-4A7E-BCFB-E804EBA47E8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40334" y="3674232"/>
                        <a:ext cx="1630362" cy="12827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对象 17">
            <a:extLst>
              <a:ext uri="{FF2B5EF4-FFF2-40B4-BE49-F238E27FC236}">
                <a16:creationId xmlns:a16="http://schemas.microsoft.com/office/drawing/2014/main" id="{A58F8D9D-8523-4A5F-A970-26D17A1AC16D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942381" y="3689087"/>
          <a:ext cx="1614487" cy="12747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9" imgW="4128875" imgH="3256863" progId="Prism8.Document">
                  <p:embed/>
                </p:oleObj>
              </mc:Choice>
              <mc:Fallback>
                <p:oleObj name="Prism 8" r:id="rId9" imgW="4128875" imgH="3256863" progId="Prism8.Document">
                  <p:embed/>
                  <p:pic>
                    <p:nvPicPr>
                      <p:cNvPr id="18" name="对象 17">
                        <a:extLst>
                          <a:ext uri="{FF2B5EF4-FFF2-40B4-BE49-F238E27FC236}">
                            <a16:creationId xmlns:a16="http://schemas.microsoft.com/office/drawing/2014/main" id="{A58F8D9D-8523-4A5F-A970-26D17A1AC16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942381" y="3689087"/>
                        <a:ext cx="1614487" cy="12747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对象 18">
            <a:extLst>
              <a:ext uri="{FF2B5EF4-FFF2-40B4-BE49-F238E27FC236}">
                <a16:creationId xmlns:a16="http://schemas.microsoft.com/office/drawing/2014/main" id="{00BCF5B7-7BF9-476D-9A6A-536A5A73349C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399092" y="3696915"/>
          <a:ext cx="1627800" cy="1282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1" imgW="4139400" imgH="3265877" progId="Prism8.Document">
                  <p:embed/>
                </p:oleObj>
              </mc:Choice>
              <mc:Fallback>
                <p:oleObj name="Prism 8" r:id="rId11" imgW="4139400" imgH="3265877" progId="Prism8.Document">
                  <p:embed/>
                  <p:pic>
                    <p:nvPicPr>
                      <p:cNvPr id="19" name="对象 18">
                        <a:extLst>
                          <a:ext uri="{FF2B5EF4-FFF2-40B4-BE49-F238E27FC236}">
                            <a16:creationId xmlns:a16="http://schemas.microsoft.com/office/drawing/2014/main" id="{00BCF5B7-7BF9-476D-9A6A-536A5A73349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399092" y="3696915"/>
                        <a:ext cx="1627800" cy="12827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" name="对象 19">
            <a:extLst>
              <a:ext uri="{FF2B5EF4-FFF2-40B4-BE49-F238E27FC236}">
                <a16:creationId xmlns:a16="http://schemas.microsoft.com/office/drawing/2014/main" id="{3CF1CA9B-039A-4FD0-936B-60FADD57A263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942381" y="2039563"/>
          <a:ext cx="1657349" cy="130530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3" imgW="4139400" imgH="3256513" progId="Prism8.Document">
                  <p:embed/>
                </p:oleObj>
              </mc:Choice>
              <mc:Fallback>
                <p:oleObj name="Prism 8" r:id="rId13" imgW="4139400" imgH="3256513" progId="Prism8.Document">
                  <p:embed/>
                  <p:pic>
                    <p:nvPicPr>
                      <p:cNvPr id="20" name="对象 19">
                        <a:extLst>
                          <a:ext uri="{FF2B5EF4-FFF2-40B4-BE49-F238E27FC236}">
                            <a16:creationId xmlns:a16="http://schemas.microsoft.com/office/drawing/2014/main" id="{3CF1CA9B-039A-4FD0-936B-60FADD57A26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1942381" y="2039563"/>
                        <a:ext cx="1657349" cy="130530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对象 20">
            <a:extLst>
              <a:ext uri="{FF2B5EF4-FFF2-40B4-BE49-F238E27FC236}">
                <a16:creationId xmlns:a16="http://schemas.microsoft.com/office/drawing/2014/main" id="{956D6265-E857-4E06-B312-5870A4DCC44D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944531" y="337184"/>
          <a:ext cx="1711576" cy="13477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5" imgW="4139400" imgH="3256513" progId="Prism8.Document">
                  <p:embed/>
                </p:oleObj>
              </mc:Choice>
              <mc:Fallback>
                <p:oleObj name="Prism 8" r:id="rId15" imgW="4139400" imgH="3256513" progId="Prism8.Document">
                  <p:embed/>
                  <p:pic>
                    <p:nvPicPr>
                      <p:cNvPr id="21" name="对象 20">
                        <a:extLst>
                          <a:ext uri="{FF2B5EF4-FFF2-40B4-BE49-F238E27FC236}">
                            <a16:creationId xmlns:a16="http://schemas.microsoft.com/office/drawing/2014/main" id="{956D6265-E857-4E06-B312-5870A4DCC44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1944531" y="337184"/>
                        <a:ext cx="1711576" cy="13477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对象 21">
            <a:extLst>
              <a:ext uri="{FF2B5EF4-FFF2-40B4-BE49-F238E27FC236}">
                <a16:creationId xmlns:a16="http://schemas.microsoft.com/office/drawing/2014/main" id="{BE12A81A-5426-4FE6-9B46-CF750C3078B5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429000" y="345121"/>
          <a:ext cx="1704975" cy="13398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7" imgW="4139400" imgH="3256513" progId="Prism8.Document">
                  <p:embed/>
                </p:oleObj>
              </mc:Choice>
              <mc:Fallback>
                <p:oleObj name="Prism 8" r:id="rId17" imgW="4139400" imgH="3256513" progId="Prism8.Document">
                  <p:embed/>
                  <p:pic>
                    <p:nvPicPr>
                      <p:cNvPr id="22" name="对象 21">
                        <a:extLst>
                          <a:ext uri="{FF2B5EF4-FFF2-40B4-BE49-F238E27FC236}">
                            <a16:creationId xmlns:a16="http://schemas.microsoft.com/office/drawing/2014/main" id="{BE12A81A-5426-4FE6-9B46-CF750C3078B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3429000" y="345121"/>
                        <a:ext cx="1704975" cy="13398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对象 22">
            <a:extLst>
              <a:ext uri="{FF2B5EF4-FFF2-40B4-BE49-F238E27FC236}">
                <a16:creationId xmlns:a16="http://schemas.microsoft.com/office/drawing/2014/main" id="{6CF50A2B-B6E5-4FEF-93F4-1F01647E4A60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883150" y="338138"/>
          <a:ext cx="1706563" cy="13430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9" imgW="4128875" imgH="3247503" progId="Prism8.Document">
                  <p:embed/>
                </p:oleObj>
              </mc:Choice>
              <mc:Fallback>
                <p:oleObj name="Prism 8" r:id="rId19" imgW="4128875" imgH="3247503" progId="Prism8.Document">
                  <p:embed/>
                  <p:pic>
                    <p:nvPicPr>
                      <p:cNvPr id="23" name="对象 22">
                        <a:extLst>
                          <a:ext uri="{FF2B5EF4-FFF2-40B4-BE49-F238E27FC236}">
                            <a16:creationId xmlns:a16="http://schemas.microsoft.com/office/drawing/2014/main" id="{6CF50A2B-B6E5-4FEF-93F4-1F01647E4A6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4883150" y="338138"/>
                        <a:ext cx="1706563" cy="13430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对象 23">
            <a:extLst>
              <a:ext uri="{FF2B5EF4-FFF2-40B4-BE49-F238E27FC236}">
                <a16:creationId xmlns:a16="http://schemas.microsoft.com/office/drawing/2014/main" id="{FF739742-14D6-4619-8FA6-27E2C931CF3C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05252" y="2029623"/>
          <a:ext cx="1704975" cy="13414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1" imgW="4139400" imgH="3256513" progId="Prism8.Document">
                  <p:embed/>
                </p:oleObj>
              </mc:Choice>
              <mc:Fallback>
                <p:oleObj name="Prism 8" r:id="rId21" imgW="4139400" imgH="3256513" progId="Prism8.Document">
                  <p:embed/>
                  <p:pic>
                    <p:nvPicPr>
                      <p:cNvPr id="24" name="对象 23">
                        <a:extLst>
                          <a:ext uri="{FF2B5EF4-FFF2-40B4-BE49-F238E27FC236}">
                            <a16:creationId xmlns:a16="http://schemas.microsoft.com/office/drawing/2014/main" id="{FF739742-14D6-4619-8FA6-27E2C931CF3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405252" y="2029623"/>
                        <a:ext cx="1704975" cy="13414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对象 3">
            <a:extLst>
              <a:ext uri="{FF2B5EF4-FFF2-40B4-BE49-F238E27FC236}">
                <a16:creationId xmlns:a16="http://schemas.microsoft.com/office/drawing/2014/main" id="{D5BA3D72-B255-4F00-8049-7B12598F1C2A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18035" y="337184"/>
          <a:ext cx="1715476" cy="134942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3" imgW="4128875" imgH="3247503" progId="Prism8.Document">
                  <p:embed/>
                </p:oleObj>
              </mc:Choice>
              <mc:Fallback>
                <p:oleObj name="Prism 8" r:id="rId23" imgW="4128875" imgH="3247503" progId="Prism8.Document">
                  <p:embed/>
                  <p:pic>
                    <p:nvPicPr>
                      <p:cNvPr id="4" name="对象 3">
                        <a:extLst>
                          <a:ext uri="{FF2B5EF4-FFF2-40B4-BE49-F238E27FC236}">
                            <a16:creationId xmlns:a16="http://schemas.microsoft.com/office/drawing/2014/main" id="{D5BA3D72-B255-4F00-8049-7B12598F1C2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418035" y="337184"/>
                        <a:ext cx="1715476" cy="134942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5" name="文本框 24">
            <a:extLst>
              <a:ext uri="{FF2B5EF4-FFF2-40B4-BE49-F238E27FC236}">
                <a16:creationId xmlns:a16="http://schemas.microsoft.com/office/drawing/2014/main" id="{F1519E23-D62F-40FC-9D7A-23066C775329}"/>
              </a:ext>
            </a:extLst>
          </p:cNvPr>
          <p:cNvSpPr txBox="1"/>
          <p:nvPr/>
        </p:nvSpPr>
        <p:spPr>
          <a:xfrm>
            <a:off x="697335" y="1616869"/>
            <a:ext cx="137409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B2M1 (19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gGAATCTTTGGAGTACCTG</a:t>
            </a:r>
            <a:endParaRPr kumimoji="1" lang="en-US" altLang="zh-CN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B2M1 (20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gTGAATCTTTGGAGTACCTG</a:t>
            </a:r>
            <a:endParaRPr kumimoji="1" lang="en-US" altLang="zh-CN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B2M1 (21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gCTGAATCTTTGGAGTACCTG</a:t>
            </a:r>
            <a:endParaRPr kumimoji="1" lang="en-US" altLang="zh-CN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B2M1 (22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gCCTGAATCTTTGGAGTACCTG</a:t>
            </a:r>
            <a:endParaRPr kumimoji="1" lang="en-US" altLang="zh-CN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B2M1 (23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gACCTGAATCTTTGGAGTACCTG</a:t>
            </a:r>
            <a:endParaRPr kumimoji="1" lang="en-US" altLang="zh-CN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5EE6281E-5567-4C00-BE99-AB9C88240F1D}"/>
              </a:ext>
            </a:extLst>
          </p:cNvPr>
          <p:cNvSpPr txBox="1"/>
          <p:nvPr/>
        </p:nvSpPr>
        <p:spPr>
          <a:xfrm>
            <a:off x="2192165" y="1614658"/>
            <a:ext cx="137890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B2M2 (19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gCAGCCCAAGATAGTTAAG</a:t>
            </a:r>
            <a:endParaRPr kumimoji="1" lang="en-US" altLang="zh-CN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B2M2 (20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gACAGCCCAAGATAGTTAAG</a:t>
            </a:r>
            <a:endParaRPr kumimoji="1" lang="en-US" altLang="zh-CN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B2M2 (21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gCACAGCCCAAGATAGTTAAG</a:t>
            </a:r>
            <a:endParaRPr kumimoji="1" lang="en-US" altLang="zh-CN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B2M2 (22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GTCACAGCCCAAGATAGTTAAG</a:t>
            </a: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B2M2 (23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gGTCACAGCCCAAGATAGTTAAG</a:t>
            </a:r>
            <a:endParaRPr kumimoji="1" lang="en-US" altLang="zh-CN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7608992D-FBE3-4EA0-A774-2DC44E8609F1}"/>
              </a:ext>
            </a:extLst>
          </p:cNvPr>
          <p:cNvSpPr txBox="1"/>
          <p:nvPr/>
        </p:nvSpPr>
        <p:spPr>
          <a:xfrm>
            <a:off x="5132879" y="1615964"/>
            <a:ext cx="139974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CCR5 (19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gTGTGTTTGCGTCTCTCCC</a:t>
            </a:r>
            <a:endParaRPr kumimoji="1" lang="en-US" altLang="zh-CN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CCR5 (20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GCTGTGTTTGCGTCTCTCCC</a:t>
            </a: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CCR5 (21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GGCTGTGTTTGCGTCTCTCCC</a:t>
            </a: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CCR5 (22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gGGCTGTGTTTGCGTCTCTCCC</a:t>
            </a:r>
            <a:endParaRPr kumimoji="1" lang="en-US" altLang="zh-CN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CCR5 (23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GTGGCTGTGTTTGCGTCTCTCCC</a:t>
            </a: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A39DCB60-70A2-4EE0-B4F2-38583E55446E}"/>
              </a:ext>
            </a:extLst>
          </p:cNvPr>
          <p:cNvSpPr txBox="1"/>
          <p:nvPr/>
        </p:nvSpPr>
        <p:spPr>
          <a:xfrm>
            <a:off x="3673495" y="1614658"/>
            <a:ext cx="138852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sgCIITA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 (19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gAATCTCTGAGGCTGGAAC</a:t>
            </a:r>
            <a:endParaRPr kumimoji="1" lang="en-US" altLang="zh-CN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sgCIITA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 (20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gAAATCTCTGAGGCTGGAAC</a:t>
            </a:r>
            <a:endParaRPr kumimoji="1" lang="en-US" altLang="zh-CN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sgCIITA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 (21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GCAAATCTCTGAGGCTGGAAC</a:t>
            </a:r>
          </a:p>
          <a:p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sgCIITA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 (22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GGCAAATCTCTGAGGCTGGAAC</a:t>
            </a:r>
          </a:p>
          <a:p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sgCIITA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 (23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gGGCAAATCTCTGAGGCTGGAAC</a:t>
            </a:r>
            <a:endParaRPr kumimoji="1" lang="en-US" altLang="zh-CN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605629EE-4256-4A70-A8A3-30E48D62B93B}"/>
              </a:ext>
            </a:extLst>
          </p:cNvPr>
          <p:cNvSpPr txBox="1"/>
          <p:nvPr/>
        </p:nvSpPr>
        <p:spPr>
          <a:xfrm>
            <a:off x="5073567" y="3289533"/>
            <a:ext cx="145905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AAVS1c (19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GCAGAGAGCAAGGGGAAGA</a:t>
            </a: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AAVS1c (20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gGCAGAGAGCAAGGGGAAGA</a:t>
            </a:r>
            <a:endParaRPr kumimoji="1" lang="en-US" altLang="zh-CN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AAVS1c (21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gAGCAGAGAGCAAGGGGAAGA</a:t>
            </a:r>
            <a:endParaRPr kumimoji="1" lang="en-US" altLang="zh-CN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AAVS1c (22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gCAGCAGAGAGCAAGGGGAAGA</a:t>
            </a:r>
            <a:endParaRPr kumimoji="1" lang="en-US" altLang="zh-CN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AAVS1c (23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gACAGCAGAGAGCAAGGGGAAGA</a:t>
            </a:r>
            <a:endParaRPr kumimoji="1" lang="en-US" altLang="zh-CN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A8845050-C82B-4C31-8A22-F81EDF16CD3A}"/>
              </a:ext>
            </a:extLst>
          </p:cNvPr>
          <p:cNvSpPr txBox="1"/>
          <p:nvPr/>
        </p:nvSpPr>
        <p:spPr>
          <a:xfrm>
            <a:off x="3638866" y="3289533"/>
            <a:ext cx="146546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AAVS1d (19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GGGGAGCTGCCCAAATGAA</a:t>
            </a: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AAVS1d (20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gGGGGAGCTGCCCAAATGAA</a:t>
            </a:r>
            <a:endParaRPr kumimoji="1" lang="en-US" altLang="zh-CN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AAVS1d (21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gAGGGGAGCTGCCCAAATGAA</a:t>
            </a:r>
            <a:endParaRPr kumimoji="1" lang="en-US" altLang="zh-CN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AAVS1d (22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GTAGGGGAGCTGCCCAAATGAA</a:t>
            </a: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AAVS1d (23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GGTAGGGGAGCTGCCCAAATGAA</a:t>
            </a: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F41A9024-AB6B-4DAF-A5AD-A53EC26290B7}"/>
              </a:ext>
            </a:extLst>
          </p:cNvPr>
          <p:cNvSpPr txBox="1"/>
          <p:nvPr/>
        </p:nvSpPr>
        <p:spPr>
          <a:xfrm>
            <a:off x="2188012" y="4895807"/>
            <a:ext cx="138852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ALB-1 (19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gTTGGTTAGGCTAGGGCTT</a:t>
            </a:r>
            <a:endParaRPr kumimoji="1" lang="en-US" altLang="zh-CN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ALB-1 (20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GTTTGGTTAGGCTAGGGCTT</a:t>
            </a: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ALB-1 (21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gGTTTGGTTAGGCTAGGGCTT</a:t>
            </a:r>
            <a:endParaRPr kumimoji="1" lang="en-US" altLang="zh-CN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ALB-1 (22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gTGTTTGGTTAGGCTAGGGCTT</a:t>
            </a:r>
            <a:endParaRPr kumimoji="1" lang="en-US" altLang="zh-CN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ALB-1 (23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gATGTTTGGTTAGGCTAGGGCTT</a:t>
            </a:r>
            <a:endParaRPr kumimoji="1" lang="en-US" altLang="zh-CN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8F72D066-1314-4884-A978-DF66D2D566E1}"/>
              </a:ext>
            </a:extLst>
          </p:cNvPr>
          <p:cNvSpPr txBox="1"/>
          <p:nvPr/>
        </p:nvSpPr>
        <p:spPr>
          <a:xfrm>
            <a:off x="661582" y="4895807"/>
            <a:ext cx="139172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PD1 (19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GGGTTCCAGGGCCTGTCTG</a:t>
            </a: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PD1 (20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GGGGTTCCAGGGCCTGTCTG</a:t>
            </a: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PD1 (21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GGGGGTTCCAGGGCCTGTCTG</a:t>
            </a: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PD1 (22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GGGGGGTTCCAGGGCCTGTCTG</a:t>
            </a: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PD1 (23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GGGGGGGTTCCAGGGCCTGTCTG</a:t>
            </a: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73A3F7A5-0AB2-4191-87BD-924C7AA2B3B6}"/>
              </a:ext>
            </a:extLst>
          </p:cNvPr>
          <p:cNvSpPr txBox="1"/>
          <p:nvPr/>
        </p:nvSpPr>
        <p:spPr>
          <a:xfrm>
            <a:off x="3629634" y="4911401"/>
            <a:ext cx="140294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ALB-2 (19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GGCTTTGTACATGTGGGAC</a:t>
            </a: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ALB-2 (20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gGGCTTTGTACATGTGGGAC</a:t>
            </a:r>
            <a:endParaRPr kumimoji="1" lang="en-US" altLang="zh-CN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ALB-2 (21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GAGGCTTTGTACATGTGGGAC</a:t>
            </a: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ALB-2 (22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GGAGGCTTTGTACATGTGGGAC</a:t>
            </a: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ALB-2 (23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gGGAGGCTTTGTACATGTGGGAC</a:t>
            </a:r>
            <a:endParaRPr kumimoji="1" lang="en-US" altLang="zh-CN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E38A3CFF-91B5-48E6-A26D-CE707DCA8E96}"/>
              </a:ext>
            </a:extLst>
          </p:cNvPr>
          <p:cNvSpPr txBox="1"/>
          <p:nvPr/>
        </p:nvSpPr>
        <p:spPr>
          <a:xfrm>
            <a:off x="677291" y="3300502"/>
            <a:ext cx="141577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CD326 (19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GCTGGTGTGTGAACACTGC</a:t>
            </a: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CD326 (20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gGCTGGTGTGTGAACACTGC</a:t>
            </a:r>
            <a:endParaRPr kumimoji="1" lang="en-US" altLang="zh-CN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CD326 (21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GTGCTGGTGTGTGAACACTGC</a:t>
            </a: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CD326 (22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gGTGCTGGTGTGTGAACACTGC</a:t>
            </a:r>
            <a:endParaRPr kumimoji="1" lang="en-US" altLang="zh-CN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CD326 (23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gTGTGCTGGTGTGTGAACACTGC</a:t>
            </a:r>
            <a:endParaRPr kumimoji="1" lang="en-US" altLang="zh-CN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68642260-89D5-4E6B-A847-40EC96301A5A}"/>
              </a:ext>
            </a:extLst>
          </p:cNvPr>
          <p:cNvSpPr txBox="1"/>
          <p:nvPr/>
        </p:nvSpPr>
        <p:spPr>
          <a:xfrm>
            <a:off x="2219888" y="3302284"/>
            <a:ext cx="141897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sgTRAC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 (19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gGGGGAAGAAGGTGTCTTC</a:t>
            </a:r>
            <a:endParaRPr kumimoji="1" lang="en-US" altLang="zh-CN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sgTRAC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 (20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gTGGGGAAGAAGGTGTCTTC</a:t>
            </a:r>
            <a:endParaRPr kumimoji="1" lang="en-US" altLang="zh-CN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sgTRAC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 (21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GCTGGGGAAGAAGGTGTCTTC</a:t>
            </a:r>
          </a:p>
          <a:p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sgTRAC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 (22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GGCTGGGGAAGAAGGTGTCTTC</a:t>
            </a:r>
          </a:p>
          <a:p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sgTRAC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 (23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GGGCTGGGGAAGAAGGTGTCTTC</a:t>
            </a:r>
          </a:p>
        </p:txBody>
      </p:sp>
    </p:spTree>
    <p:extLst>
      <p:ext uri="{BB962C8B-B14F-4D97-AF65-F5344CB8AC3E}">
        <p14:creationId xmlns:p14="http://schemas.microsoft.com/office/powerpoint/2010/main" val="4403445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38</TotalTime>
  <Words>333</Words>
  <Application>Microsoft Office PowerPoint</Application>
  <PresentationFormat>A4 纸张(210x297 毫米)</PresentationFormat>
  <Paragraphs>57</Paragraphs>
  <Slides>1</Slides>
  <Notes>1</Notes>
  <HiddenSlides>0</HiddenSlides>
  <MMClips>0</MMClips>
  <ScaleCrop>false</ScaleCrop>
  <HeadingPairs>
    <vt:vector size="8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Office 主题​​</vt:lpstr>
      <vt:lpstr>Prism 8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ixue Yang</dc:creator>
  <cp:lastModifiedBy>Zhixue Yang</cp:lastModifiedBy>
  <cp:revision>14</cp:revision>
  <dcterms:created xsi:type="dcterms:W3CDTF">2021-10-03T13:46:32Z</dcterms:created>
  <dcterms:modified xsi:type="dcterms:W3CDTF">2022-06-06T13:28:01Z</dcterms:modified>
</cp:coreProperties>
</file>